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60" r:id="rId3"/>
    <p:sldId id="268" r:id="rId4"/>
    <p:sldId id="273" r:id="rId5"/>
    <p:sldId id="275" r:id="rId6"/>
  </p:sldIdLst>
  <p:sldSz cx="9144000" cy="6858000" type="screen4x3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167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E3C45-EC0D-40CD-8E4E-B3B68D9DC1FD}" type="datetimeFigureOut">
              <a:rPr lang="en-GB" smtClean="0"/>
              <a:t>2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B93E5-D13C-4DB2-88A5-201B8EA5A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72769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E3C45-EC0D-40CD-8E4E-B3B68D9DC1FD}" type="datetimeFigureOut">
              <a:rPr lang="en-GB" smtClean="0"/>
              <a:t>2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B93E5-D13C-4DB2-88A5-201B8EA5A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42935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E3C45-EC0D-40CD-8E4E-B3B68D9DC1FD}" type="datetimeFigureOut">
              <a:rPr lang="en-GB" smtClean="0"/>
              <a:t>2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B93E5-D13C-4DB2-88A5-201B8EA5A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66992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E3C45-EC0D-40CD-8E4E-B3B68D9DC1FD}" type="datetimeFigureOut">
              <a:rPr lang="en-GB" smtClean="0"/>
              <a:t>2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B93E5-D13C-4DB2-88A5-201B8EA5A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70843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E3C45-EC0D-40CD-8E4E-B3B68D9DC1FD}" type="datetimeFigureOut">
              <a:rPr lang="en-GB" smtClean="0"/>
              <a:t>2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B93E5-D13C-4DB2-88A5-201B8EA5A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36699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E3C45-EC0D-40CD-8E4E-B3B68D9DC1FD}" type="datetimeFigureOut">
              <a:rPr lang="en-GB" smtClean="0"/>
              <a:t>2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B93E5-D13C-4DB2-88A5-201B8EA5A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5238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E3C45-EC0D-40CD-8E4E-B3B68D9DC1FD}" type="datetimeFigureOut">
              <a:rPr lang="en-GB" smtClean="0"/>
              <a:t>22/06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B93E5-D13C-4DB2-88A5-201B8EA5A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34434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E3C45-EC0D-40CD-8E4E-B3B68D9DC1FD}" type="datetimeFigureOut">
              <a:rPr lang="en-GB" smtClean="0"/>
              <a:t>22/06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B93E5-D13C-4DB2-88A5-201B8EA5A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7516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E3C45-EC0D-40CD-8E4E-B3B68D9DC1FD}" type="datetimeFigureOut">
              <a:rPr lang="en-GB" smtClean="0"/>
              <a:t>22/06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B93E5-D13C-4DB2-88A5-201B8EA5A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46388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E3C45-EC0D-40CD-8E4E-B3B68D9DC1FD}" type="datetimeFigureOut">
              <a:rPr lang="en-GB" smtClean="0"/>
              <a:t>2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B93E5-D13C-4DB2-88A5-201B8EA5A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88261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E3C45-EC0D-40CD-8E4E-B3B68D9DC1FD}" type="datetimeFigureOut">
              <a:rPr lang="en-GB" smtClean="0"/>
              <a:t>22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B93E5-D13C-4DB2-88A5-201B8EA5A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9931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3E3C45-EC0D-40CD-8E4E-B3B68D9DC1FD}" type="datetimeFigureOut">
              <a:rPr lang="en-GB" smtClean="0"/>
              <a:t>22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EB93E5-D13C-4DB2-88A5-201B8EA5A5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48388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AutoShape 3"/>
          <p:cNvSpPr>
            <a:spLocks noChangeAspect="1" noChangeArrowheads="1" noTextEdit="1"/>
          </p:cNvSpPr>
          <p:nvPr/>
        </p:nvSpPr>
        <p:spPr bwMode="auto">
          <a:xfrm>
            <a:off x="-1237515" y="363895"/>
            <a:ext cx="5881687" cy="5776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2" name="Rectangle 1"/>
          <p:cNvSpPr/>
          <p:nvPr/>
        </p:nvSpPr>
        <p:spPr>
          <a:xfrm>
            <a:off x="773723" y="678644"/>
            <a:ext cx="7684477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homozygote and heterozygote single nucleotide polymorphism (SNP) ratios across the chromosomes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6769" y="1383852"/>
            <a:ext cx="6226787" cy="36019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123988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D:\NAS_2020\Manuscript\GBS_melon\melon-structure.jp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4399" y="1345223"/>
            <a:ext cx="7280031" cy="4299439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/>
          <p:nvPr/>
        </p:nvSpPr>
        <p:spPr>
          <a:xfrm>
            <a:off x="307731" y="461415"/>
            <a:ext cx="865163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MIXTURE results assuming two ancestral populations.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r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 ancestry components. Stacked bars represent samples. Samples are arranged according to taxonomy as indicated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x-axis.</a:t>
            </a:r>
          </a:p>
        </p:txBody>
      </p:sp>
    </p:spTree>
    <p:extLst>
      <p:ext uri="{BB962C8B-B14F-4D97-AF65-F5344CB8AC3E}">
        <p14:creationId xmlns:p14="http://schemas.microsoft.com/office/powerpoint/2010/main" val="29494732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548481" y="1825971"/>
            <a:ext cx="8036169" cy="2899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latinLnBrk="1">
              <a:lnSpc>
                <a:spcPct val="107000"/>
              </a:lnSpc>
              <a:spcAft>
                <a:spcPts val="800"/>
              </a:spcAft>
            </a:pPr>
            <a:r>
              <a:rPr lang="en-GB" sz="1200" b="1" kern="1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</a:t>
            </a:r>
            <a:r>
              <a:rPr lang="en-GB" sz="1200" b="1" kern="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3 </a:t>
            </a:r>
            <a:r>
              <a:rPr lang="en-GB" sz="1200" kern="1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ingle </a:t>
            </a:r>
            <a:r>
              <a:rPr lang="en-GB" sz="1200" kern="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nucleotide polymorphisms (SNPs</a:t>
            </a:r>
            <a:r>
              <a:rPr lang="en-GB" sz="1200" kern="1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 markers </a:t>
            </a:r>
            <a:r>
              <a:rPr lang="en-GB" sz="1200" kern="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o discriminate the </a:t>
            </a:r>
            <a:r>
              <a:rPr lang="en-GB" sz="1200" kern="1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uskmelon</a:t>
            </a:r>
            <a:r>
              <a:rPr lang="en-GB" sz="1200" kern="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</a:t>
            </a:r>
            <a:r>
              <a:rPr lang="en-GB" sz="1200" kern="100" dirty="0" err="1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akuwa</a:t>
            </a:r>
            <a:r>
              <a:rPr lang="en-GB" sz="1200" kern="1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</a:t>
            </a:r>
            <a:r>
              <a:rPr lang="en-GB" sz="1200" kern="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nd cantaloupe </a:t>
            </a:r>
            <a:r>
              <a:rPr lang="en-GB" sz="1200" kern="1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varieties.</a:t>
            </a:r>
            <a:endParaRPr lang="en-GB" sz="12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8554" y="2848708"/>
            <a:ext cx="7656024" cy="10679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46849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9431" y="682768"/>
            <a:ext cx="4940424" cy="6078975"/>
          </a:xfrm>
          <a:prstGeom prst="rect">
            <a:avLst/>
          </a:prstGeom>
        </p:spPr>
      </p:pic>
      <p:sp>
        <p:nvSpPr>
          <p:cNvPr id="12" name="Rectangle 11"/>
          <p:cNvSpPr/>
          <p:nvPr/>
        </p:nvSpPr>
        <p:spPr>
          <a:xfrm>
            <a:off x="466725" y="323648"/>
            <a:ext cx="8255244" cy="4875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latinLnBrk="1">
              <a:lnSpc>
                <a:spcPct val="107000"/>
              </a:lnSpc>
              <a:spcAft>
                <a:spcPts val="800"/>
              </a:spcAft>
            </a:pPr>
            <a:r>
              <a:rPr lang="en-GB" sz="1200" b="1" kern="1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</a:t>
            </a:r>
            <a:r>
              <a:rPr lang="en-GB" sz="1200" b="1" kern="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4 </a:t>
            </a:r>
            <a:r>
              <a:rPr lang="en-GB" sz="1200" kern="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anhattan plots of the genome-wide association analysis (GWAS) for the phenotypic traits of 1000 seed weight (TSW), length, and width in the melon populations.</a:t>
            </a:r>
            <a:endParaRPr lang="en-GB" sz="1200" kern="100" dirty="0"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42829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/>
          <p:cNvSpPr/>
          <p:nvPr/>
        </p:nvSpPr>
        <p:spPr>
          <a:xfrm>
            <a:off x="193431" y="181211"/>
            <a:ext cx="8715438" cy="10804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GB" sz="1200" b="1" kern="1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S5 </a:t>
            </a:r>
            <a:r>
              <a:rPr lang="en-GB" sz="1200" kern="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he candidate genes </a:t>
            </a:r>
            <a:r>
              <a:rPr lang="en-GB" sz="1200" kern="1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a) </a:t>
            </a:r>
            <a:r>
              <a:rPr lang="en-GB" sz="1200" kern="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rotein ABIL1 and </a:t>
            </a:r>
            <a:r>
              <a:rPr lang="en-GB" sz="1200" kern="1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b)</a:t>
            </a:r>
            <a:r>
              <a:rPr lang="en-GB" sz="1200" kern="100" dirty="0" smtClean="0">
                <a:solidFill>
                  <a:srgbClr val="FF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GB" sz="1200" kern="100" dirty="0" err="1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itin</a:t>
            </a:r>
            <a:r>
              <a:rPr lang="en-GB" sz="1200" kern="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homolog isoform x2) underlying the 1,000 seed weight (TSW) variation in melon groups. Each panel shows the association statistics for TSW in melon accessions, the location of genome-wide association study (GWAS)-associated region on chromosome 6, and candidate </a:t>
            </a:r>
            <a:r>
              <a:rPr lang="en-GB" sz="1200" kern="1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genes, </a:t>
            </a:r>
            <a:r>
              <a:rPr lang="en-GB" sz="1200" kern="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nd the LD haplotype </a:t>
            </a:r>
            <a:r>
              <a:rPr lang="en-GB" sz="1200" kern="100" dirty="0" err="1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heatmap</a:t>
            </a:r>
            <a:r>
              <a:rPr lang="en-GB" sz="1200" kern="1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for the GWAS region harbouring genes and the segregating single nucleotide polymorphisms (SNPs) (S6_875904 and S6_5912593). The presence of genes and the segregating SNPs are indicated by the red cursor in each location of the figure. </a:t>
            </a:r>
            <a:r>
              <a:rPr lang="en-GB" sz="1200" kern="1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endParaRPr lang="en-GB" sz="12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302399" y="1289659"/>
            <a:ext cx="8478910" cy="4491732"/>
            <a:chOff x="539792" y="1233097"/>
            <a:chExt cx="8478910" cy="4491732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03877" y="1233097"/>
              <a:ext cx="4314825" cy="4386228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9792" y="1329810"/>
              <a:ext cx="4120125" cy="4395019"/>
            </a:xfrm>
            <a:prstGeom prst="rect">
              <a:avLst/>
            </a:prstGeom>
          </p:spPr>
        </p:pic>
        <p:sp>
          <p:nvSpPr>
            <p:cNvPr id="18" name="TextBox 17"/>
            <p:cNvSpPr txBox="1"/>
            <p:nvPr/>
          </p:nvSpPr>
          <p:spPr>
            <a:xfrm>
              <a:off x="1131274" y="1379634"/>
              <a:ext cx="115223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 </a:t>
              </a:r>
              <a:r>
                <a:rPr lang="en-US" sz="1000" kern="1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Protein ABIL1 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66641" y="1335673"/>
              <a:ext cx="16514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 </a:t>
              </a:r>
              <a:r>
                <a:rPr lang="en-US" sz="1000" kern="100" dirty="0" err="1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titin</a:t>
              </a:r>
              <a:r>
                <a:rPr lang="en-US" sz="1000" kern="1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 homolog isoform </a:t>
              </a:r>
              <a:r>
                <a:rPr lang="en-US" sz="1000" kern="100" dirty="0" smtClean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x2</a:t>
              </a:r>
              <a:endParaRPr lang="en-GB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617917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83</TotalTime>
  <Words>221</Words>
  <Application>Microsoft Office PowerPoint</Application>
  <PresentationFormat>On-screen Show (4:3)</PresentationFormat>
  <Paragraphs>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맑은 고딕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</dc:creator>
  <cp:lastModifiedBy>A</cp:lastModifiedBy>
  <cp:revision>118</cp:revision>
  <cp:lastPrinted>2020-10-12T09:08:16Z</cp:lastPrinted>
  <dcterms:created xsi:type="dcterms:W3CDTF">2020-08-07T00:09:36Z</dcterms:created>
  <dcterms:modified xsi:type="dcterms:W3CDTF">2021-06-22T04:06:48Z</dcterms:modified>
</cp:coreProperties>
</file>